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51" y="8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62316B-26A6-49ED-8BBF-57E83B73E6EF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7D790E-13E0-4F70-9991-0A6E38D1E15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0356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7D790E-13E0-4F70-9991-0A6E38D1E15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32617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7D790E-13E0-4F70-9991-0A6E38D1E15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5110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E142A4-2258-FF76-39D4-7FD10BB13A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5EED806-3409-D77A-7769-272BD4F038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0DB827-4A9F-BE65-103A-09DF29A95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A5E9D9-F2A5-E806-85B9-8A65D02D3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288634-7E6F-28FF-D234-FE7EE4615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78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A35670-82B2-44E1-3156-10986E5CF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43AEFC2-3266-7E07-4440-D585D0290E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32F587-88F5-8525-692E-A817FDC8B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F60429-3155-1EC1-5FBC-047A2F076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C51111-7833-8818-1981-97ADA49E3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823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49C9297-B81F-5545-03C9-6DBBAB207C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E5192B1-9701-9CF6-C81C-C6A0267CC8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1612F-2C7A-ABE6-6890-2267645CF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C9188F-4276-536F-3BCF-F12239D7C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78A23B-77A4-E911-9002-1601F5979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2098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2E522B-6090-BBB2-C91E-1443E9B05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8D23BC-E2EB-3CB3-8AD3-DD92DBDDD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129520-CEE6-8B99-F855-23B86F91D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8A9E9-BE87-EC71-5D51-B8FAD0BD9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FBAA0C-A6F4-ABBA-6571-43E0013F6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218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0DBDC6-C1A3-9807-4435-CB73869ED8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061D6F-4921-6EBD-716F-96CB5AAD3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0F58CB-5913-40C4-EE53-CF1769D68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41A0AE-8BDE-617C-CED6-96972118C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EA1198-483A-2CC4-310D-679C92A18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043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C39065-4087-2BEE-200C-DC7C7BB8A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87104B-F55F-B340-8EDC-56AB29013B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966893E-7D7A-7C47-8010-E8A742E60B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A23EB5-8F6F-6F2B-DD6F-7B12A99E7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DD2DC18-72B5-5E6B-3173-2D5965E2B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28A342D-6669-ECA0-4C20-1040B1A52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8650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1D6484-8FE9-EFFD-769E-07E41D269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7B4FC1-422F-769F-ED34-8343D11DE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E924985-7F36-11E3-32B4-131074941B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56AA897-A545-44BF-F9A8-F8281DA487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CB16FA6-FDDC-945F-633C-E8B362AE97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D8C74D8-D752-02D9-DAD8-8FFC292A3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EF8C654-628A-38F9-BCCE-F7B7FB4DF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4A8A546-10D5-83E6-99A8-FD4860B2A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458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8A9937-7AE1-7E3B-AF4F-63C91460F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BA87AD5-3D45-7953-E638-B21845947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6243F11-B264-B01F-C96F-81B1092E8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E8A033A-224C-C6CD-CE77-9E7D26325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1121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19D7AD4-5C31-92C6-5A63-2FE37FE8B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BBA722F-8A01-08F4-0B0D-8B089B84D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E3FA7BC-9728-9EE2-4D8F-52669D673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6802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F1DC5D-1390-DDDB-AAF0-0F349E6C0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FCC6AE-9DFE-507B-2BFF-DB441053C4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B1FFE6-857F-9713-A55B-D4C927518F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0716D4-873A-E0AD-3D76-34356E008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3C41E0-B58C-084D-B657-6732C50C0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AF4FD-CF77-8B53-86EB-624617CC5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934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DA784B-2093-5502-C19B-B0B4FEADA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A467FE2-5B20-9604-0F42-B8AB3D1177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29111AD-9267-4111-4CD4-E612FBB4FC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B576DE-81F7-4083-D9C9-4E6DD895B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1E34EB-CF8A-7F52-6774-33DEAE7FB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2C584F-FF8E-FDCF-2652-12A732130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4869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860D237-8DEE-25FE-2D7B-AE176974F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B8D5E1C-9241-F9B8-2A1C-AF82EB7B37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4011B9-14C6-F52D-6737-2B7F61CA6D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564CE8-00D3-43FB-A69E-C71F70178781}" type="datetimeFigureOut">
              <a:rPr lang="zh-CN" altLang="en-US" smtClean="0"/>
              <a:t>2023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BE7C8D-41A2-EBB2-59E3-3DE8ACB119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1CAA0D-C829-7A25-569D-92CB98F4B1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3E4A36-2010-4855-A0A8-67D742468F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403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09044768-0123-26AD-4123-957C66A54667}"/>
              </a:ext>
            </a:extLst>
          </p:cNvPr>
          <p:cNvGrpSpPr/>
          <p:nvPr/>
        </p:nvGrpSpPr>
        <p:grpSpPr>
          <a:xfrm>
            <a:off x="8190241" y="1748568"/>
            <a:ext cx="1065593" cy="1732472"/>
            <a:chOff x="8412410" y="2750614"/>
            <a:chExt cx="1058352" cy="1560648"/>
          </a:xfrm>
          <a:effectLst>
            <a:glow rad="63500">
              <a:schemeClr val="accent2">
                <a:satMod val="175000"/>
                <a:alpha val="40000"/>
              </a:schemeClr>
            </a:glow>
            <a:outerShdw blurRad="50800" dist="38100" dir="16200000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9B854DC5-759A-D518-9BA0-1D704A1848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96061" y="2750614"/>
              <a:ext cx="878864" cy="858265"/>
            </a:xfrm>
            <a:prstGeom prst="rect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p3d>
              <a:bevelT w="190500" h="38100"/>
            </a:sp3d>
          </p:spPr>
        </p:pic>
        <p:grpSp>
          <p:nvGrpSpPr>
            <p:cNvPr id="1073" name="组合 1072">
              <a:extLst>
                <a:ext uri="{FF2B5EF4-FFF2-40B4-BE49-F238E27FC236}">
                  <a16:creationId xmlns:a16="http://schemas.microsoft.com/office/drawing/2014/main" id="{116AE068-D550-7137-14DA-E12C9F5255E6}"/>
                </a:ext>
              </a:extLst>
            </p:cNvPr>
            <p:cNvGrpSpPr/>
            <p:nvPr/>
          </p:nvGrpSpPr>
          <p:grpSpPr>
            <a:xfrm rot="1558626">
              <a:off x="8564224" y="3600790"/>
              <a:ext cx="268202" cy="271731"/>
              <a:chOff x="7913022" y="4030204"/>
              <a:chExt cx="1230052" cy="1246236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1074" name="任意多边形: 形状 1073">
                <a:extLst>
                  <a:ext uri="{FF2B5EF4-FFF2-40B4-BE49-F238E27FC236}">
                    <a16:creationId xmlns:a16="http://schemas.microsoft.com/office/drawing/2014/main" id="{251C6EDE-87B9-AE9A-9A5B-6FDC56EBA11E}"/>
                  </a:ext>
                </a:extLst>
              </p:cNvPr>
              <p:cNvSpPr/>
              <p:nvPr/>
            </p:nvSpPr>
            <p:spPr>
              <a:xfrm rot="19417418">
                <a:off x="7913022" y="4070808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75" name="任意多边形: 形状 1074">
                <a:extLst>
                  <a:ext uri="{FF2B5EF4-FFF2-40B4-BE49-F238E27FC236}">
                    <a16:creationId xmlns:a16="http://schemas.microsoft.com/office/drawing/2014/main" id="{840F0D4B-ACD9-7979-E80D-04EE6CEBBB3D}"/>
                  </a:ext>
                </a:extLst>
              </p:cNvPr>
              <p:cNvSpPr/>
              <p:nvPr/>
            </p:nvSpPr>
            <p:spPr>
              <a:xfrm rot="19556879">
                <a:off x="7948332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76" name="任意多边形: 形状 1075">
                <a:extLst>
                  <a:ext uri="{FF2B5EF4-FFF2-40B4-BE49-F238E27FC236}">
                    <a16:creationId xmlns:a16="http://schemas.microsoft.com/office/drawing/2014/main" id="{13EA3FB3-B02E-16E5-73C9-04C0D8CA08B6}"/>
                  </a:ext>
                </a:extLst>
              </p:cNvPr>
              <p:cNvSpPr/>
              <p:nvPr/>
            </p:nvSpPr>
            <p:spPr>
              <a:xfrm rot="2043121" flipH="1">
                <a:off x="8419230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77" name="任意多边形: 形状 1076">
                <a:extLst>
                  <a:ext uri="{FF2B5EF4-FFF2-40B4-BE49-F238E27FC236}">
                    <a16:creationId xmlns:a16="http://schemas.microsoft.com/office/drawing/2014/main" id="{68523B44-67BD-8096-C02D-67CD9EBAC7B8}"/>
                  </a:ext>
                </a:extLst>
              </p:cNvPr>
              <p:cNvSpPr/>
              <p:nvPr/>
            </p:nvSpPr>
            <p:spPr>
              <a:xfrm rot="2076457" flipH="1">
                <a:off x="8963074" y="4069266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091" name="组合 1090">
              <a:extLst>
                <a:ext uri="{FF2B5EF4-FFF2-40B4-BE49-F238E27FC236}">
                  <a16:creationId xmlns:a16="http://schemas.microsoft.com/office/drawing/2014/main" id="{1FE50951-6660-FC75-A9AD-15124D9B1115}"/>
                </a:ext>
              </a:extLst>
            </p:cNvPr>
            <p:cNvGrpSpPr/>
            <p:nvPr/>
          </p:nvGrpSpPr>
          <p:grpSpPr>
            <a:xfrm rot="20226680">
              <a:off x="9055919" y="3620372"/>
              <a:ext cx="268202" cy="271731"/>
              <a:chOff x="7913022" y="4030204"/>
              <a:chExt cx="1230052" cy="1246236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1092" name="任意多边形: 形状 1091">
                <a:extLst>
                  <a:ext uri="{FF2B5EF4-FFF2-40B4-BE49-F238E27FC236}">
                    <a16:creationId xmlns:a16="http://schemas.microsoft.com/office/drawing/2014/main" id="{0CAE20FF-BCEA-5390-37B0-16C67FFF6D96}"/>
                  </a:ext>
                </a:extLst>
              </p:cNvPr>
              <p:cNvSpPr/>
              <p:nvPr/>
            </p:nvSpPr>
            <p:spPr>
              <a:xfrm rot="19417418">
                <a:off x="7913022" y="4070808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3" name="任意多边形: 形状 1092">
                <a:extLst>
                  <a:ext uri="{FF2B5EF4-FFF2-40B4-BE49-F238E27FC236}">
                    <a16:creationId xmlns:a16="http://schemas.microsoft.com/office/drawing/2014/main" id="{72D7DAE8-4322-D293-B6F4-EE0CF6545292}"/>
                  </a:ext>
                </a:extLst>
              </p:cNvPr>
              <p:cNvSpPr/>
              <p:nvPr/>
            </p:nvSpPr>
            <p:spPr>
              <a:xfrm rot="19556879">
                <a:off x="7948332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4" name="任意多边形: 形状 1093">
                <a:extLst>
                  <a:ext uri="{FF2B5EF4-FFF2-40B4-BE49-F238E27FC236}">
                    <a16:creationId xmlns:a16="http://schemas.microsoft.com/office/drawing/2014/main" id="{056E06C5-8B7A-12D6-3BE9-096A6EEC0A51}"/>
                  </a:ext>
                </a:extLst>
              </p:cNvPr>
              <p:cNvSpPr/>
              <p:nvPr/>
            </p:nvSpPr>
            <p:spPr>
              <a:xfrm rot="2043121" flipH="1">
                <a:off x="8419230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5" name="任意多边形: 形状 1094">
                <a:extLst>
                  <a:ext uri="{FF2B5EF4-FFF2-40B4-BE49-F238E27FC236}">
                    <a16:creationId xmlns:a16="http://schemas.microsoft.com/office/drawing/2014/main" id="{8A993738-2590-2D59-8107-2E300B23DB97}"/>
                  </a:ext>
                </a:extLst>
              </p:cNvPr>
              <p:cNvSpPr/>
              <p:nvPr/>
            </p:nvSpPr>
            <p:spPr>
              <a:xfrm rot="2076457" flipH="1">
                <a:off x="8963074" y="4069266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096" name="组合 1095">
              <a:extLst>
                <a:ext uri="{FF2B5EF4-FFF2-40B4-BE49-F238E27FC236}">
                  <a16:creationId xmlns:a16="http://schemas.microsoft.com/office/drawing/2014/main" id="{CD626AF1-3D57-1109-89D4-DFDF0BD24268}"/>
                </a:ext>
              </a:extLst>
            </p:cNvPr>
            <p:cNvGrpSpPr/>
            <p:nvPr/>
          </p:nvGrpSpPr>
          <p:grpSpPr>
            <a:xfrm rot="16200000">
              <a:off x="9200796" y="2874260"/>
              <a:ext cx="268202" cy="271731"/>
              <a:chOff x="7913022" y="4030204"/>
              <a:chExt cx="1230052" cy="1246236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1097" name="任意多边形: 形状 1096">
                <a:extLst>
                  <a:ext uri="{FF2B5EF4-FFF2-40B4-BE49-F238E27FC236}">
                    <a16:creationId xmlns:a16="http://schemas.microsoft.com/office/drawing/2014/main" id="{47593DC7-B51A-00B6-CBDE-C7D67B266871}"/>
                  </a:ext>
                </a:extLst>
              </p:cNvPr>
              <p:cNvSpPr/>
              <p:nvPr/>
            </p:nvSpPr>
            <p:spPr>
              <a:xfrm rot="19417418">
                <a:off x="7913022" y="4070808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8" name="任意多边形: 形状 1097">
                <a:extLst>
                  <a:ext uri="{FF2B5EF4-FFF2-40B4-BE49-F238E27FC236}">
                    <a16:creationId xmlns:a16="http://schemas.microsoft.com/office/drawing/2014/main" id="{13A8019A-A118-25CF-A92C-FB674D57E8D0}"/>
                  </a:ext>
                </a:extLst>
              </p:cNvPr>
              <p:cNvSpPr/>
              <p:nvPr/>
            </p:nvSpPr>
            <p:spPr>
              <a:xfrm rot="19556879">
                <a:off x="7948332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9" name="任意多边形: 形状 1098">
                <a:extLst>
                  <a:ext uri="{FF2B5EF4-FFF2-40B4-BE49-F238E27FC236}">
                    <a16:creationId xmlns:a16="http://schemas.microsoft.com/office/drawing/2014/main" id="{F3D0CBFE-FE7C-0463-790C-4192CD15B7EF}"/>
                  </a:ext>
                </a:extLst>
              </p:cNvPr>
              <p:cNvSpPr/>
              <p:nvPr/>
            </p:nvSpPr>
            <p:spPr>
              <a:xfrm rot="2043121" flipH="1">
                <a:off x="8419230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0" name="任意多边形: 形状 1099">
                <a:extLst>
                  <a:ext uri="{FF2B5EF4-FFF2-40B4-BE49-F238E27FC236}">
                    <a16:creationId xmlns:a16="http://schemas.microsoft.com/office/drawing/2014/main" id="{0738B185-192C-8680-FFC1-4923734B7237}"/>
                  </a:ext>
                </a:extLst>
              </p:cNvPr>
              <p:cNvSpPr/>
              <p:nvPr/>
            </p:nvSpPr>
            <p:spPr>
              <a:xfrm rot="2076457" flipH="1">
                <a:off x="8963074" y="4069266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101" name="组合 1100">
              <a:extLst>
                <a:ext uri="{FF2B5EF4-FFF2-40B4-BE49-F238E27FC236}">
                  <a16:creationId xmlns:a16="http://schemas.microsoft.com/office/drawing/2014/main" id="{78AE933B-8351-7EA9-94A2-66A0EC8C9F52}"/>
                </a:ext>
              </a:extLst>
            </p:cNvPr>
            <p:cNvGrpSpPr/>
            <p:nvPr/>
          </p:nvGrpSpPr>
          <p:grpSpPr>
            <a:xfrm rot="20226680">
              <a:off x="8821753" y="4039531"/>
              <a:ext cx="268202" cy="271731"/>
              <a:chOff x="7913022" y="4030204"/>
              <a:chExt cx="1230052" cy="1246236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1102" name="任意多边形: 形状 1101">
                <a:extLst>
                  <a:ext uri="{FF2B5EF4-FFF2-40B4-BE49-F238E27FC236}">
                    <a16:creationId xmlns:a16="http://schemas.microsoft.com/office/drawing/2014/main" id="{574A4AB1-BC88-BC7A-7D80-9E77B22BCF8D}"/>
                  </a:ext>
                </a:extLst>
              </p:cNvPr>
              <p:cNvSpPr/>
              <p:nvPr/>
            </p:nvSpPr>
            <p:spPr>
              <a:xfrm rot="19417418">
                <a:off x="7913022" y="4070808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3" name="任意多边形: 形状 1102">
                <a:extLst>
                  <a:ext uri="{FF2B5EF4-FFF2-40B4-BE49-F238E27FC236}">
                    <a16:creationId xmlns:a16="http://schemas.microsoft.com/office/drawing/2014/main" id="{B16BA44A-518A-7D38-11F9-764FEF98CFC2}"/>
                  </a:ext>
                </a:extLst>
              </p:cNvPr>
              <p:cNvSpPr/>
              <p:nvPr/>
            </p:nvSpPr>
            <p:spPr>
              <a:xfrm rot="19556879">
                <a:off x="7948332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4" name="任意多边形: 形状 1103">
                <a:extLst>
                  <a:ext uri="{FF2B5EF4-FFF2-40B4-BE49-F238E27FC236}">
                    <a16:creationId xmlns:a16="http://schemas.microsoft.com/office/drawing/2014/main" id="{058CB979-FE5A-4F93-2884-4AE240E3E53F}"/>
                  </a:ext>
                </a:extLst>
              </p:cNvPr>
              <p:cNvSpPr/>
              <p:nvPr/>
            </p:nvSpPr>
            <p:spPr>
              <a:xfrm rot="2043121" flipH="1">
                <a:off x="8419230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5" name="任意多边形: 形状 1104">
                <a:extLst>
                  <a:ext uri="{FF2B5EF4-FFF2-40B4-BE49-F238E27FC236}">
                    <a16:creationId xmlns:a16="http://schemas.microsoft.com/office/drawing/2014/main" id="{A5E819DA-D1E9-7CFE-A0EF-01CF2E206B26}"/>
                  </a:ext>
                </a:extLst>
              </p:cNvPr>
              <p:cNvSpPr/>
              <p:nvPr/>
            </p:nvSpPr>
            <p:spPr>
              <a:xfrm rot="2076457" flipH="1">
                <a:off x="8963074" y="4069266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106" name="组合 1105">
              <a:extLst>
                <a:ext uri="{FF2B5EF4-FFF2-40B4-BE49-F238E27FC236}">
                  <a16:creationId xmlns:a16="http://schemas.microsoft.com/office/drawing/2014/main" id="{998118C6-DDAF-1A08-4107-9E1437312C5D}"/>
                </a:ext>
              </a:extLst>
            </p:cNvPr>
            <p:cNvGrpSpPr/>
            <p:nvPr/>
          </p:nvGrpSpPr>
          <p:grpSpPr>
            <a:xfrm rot="8100000">
              <a:off x="8412410" y="2855095"/>
              <a:ext cx="268202" cy="271731"/>
              <a:chOff x="7913022" y="4030204"/>
              <a:chExt cx="1230052" cy="1246236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1107" name="任意多边形: 形状 1106">
                <a:extLst>
                  <a:ext uri="{FF2B5EF4-FFF2-40B4-BE49-F238E27FC236}">
                    <a16:creationId xmlns:a16="http://schemas.microsoft.com/office/drawing/2014/main" id="{1AB2AD6F-DDB9-2E74-C64F-1A3EEA82A316}"/>
                  </a:ext>
                </a:extLst>
              </p:cNvPr>
              <p:cNvSpPr/>
              <p:nvPr/>
            </p:nvSpPr>
            <p:spPr>
              <a:xfrm rot="19417418">
                <a:off x="7913022" y="4070808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8" name="任意多边形: 形状 1107">
                <a:extLst>
                  <a:ext uri="{FF2B5EF4-FFF2-40B4-BE49-F238E27FC236}">
                    <a16:creationId xmlns:a16="http://schemas.microsoft.com/office/drawing/2014/main" id="{5D9EA7A0-358A-14C2-4842-4B09B6707F64}"/>
                  </a:ext>
                </a:extLst>
              </p:cNvPr>
              <p:cNvSpPr/>
              <p:nvPr/>
            </p:nvSpPr>
            <p:spPr>
              <a:xfrm rot="19556879">
                <a:off x="7948332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9" name="任意多边形: 形状 1108">
                <a:extLst>
                  <a:ext uri="{FF2B5EF4-FFF2-40B4-BE49-F238E27FC236}">
                    <a16:creationId xmlns:a16="http://schemas.microsoft.com/office/drawing/2014/main" id="{8F43CEE4-F8AF-7F72-AF16-A5E0A29D30D7}"/>
                  </a:ext>
                </a:extLst>
              </p:cNvPr>
              <p:cNvSpPr/>
              <p:nvPr/>
            </p:nvSpPr>
            <p:spPr>
              <a:xfrm rot="2043121" flipH="1">
                <a:off x="8419230" y="4030204"/>
                <a:ext cx="677758" cy="1246236"/>
              </a:xfrm>
              <a:custGeom>
                <a:avLst/>
                <a:gdLst>
                  <a:gd name="connsiteX0" fmla="*/ 664533 w 677758"/>
                  <a:gd name="connsiteY0" fmla="*/ 9490 h 1246236"/>
                  <a:gd name="connsiteX1" fmla="*/ 674023 w 677758"/>
                  <a:gd name="connsiteY1" fmla="*/ 32401 h 1246236"/>
                  <a:gd name="connsiteX2" fmla="*/ 674023 w 677758"/>
                  <a:gd name="connsiteY2" fmla="*/ 456570 h 1246236"/>
                  <a:gd name="connsiteX3" fmla="*/ 677161 w 677758"/>
                  <a:gd name="connsiteY3" fmla="*/ 461319 h 1246236"/>
                  <a:gd name="connsiteX4" fmla="*/ 672155 w 677758"/>
                  <a:gd name="connsiteY4" fmla="*/ 485808 h 1246236"/>
                  <a:gd name="connsiteX5" fmla="*/ 167949 w 677758"/>
                  <a:gd name="connsiteY5" fmla="*/ 1231862 h 1246236"/>
                  <a:gd name="connsiteX6" fmla="*/ 122605 w 677758"/>
                  <a:gd name="connsiteY6" fmla="*/ 1240633 h 1246236"/>
                  <a:gd name="connsiteX7" fmla="*/ 14375 w 677758"/>
                  <a:gd name="connsiteY7" fmla="*/ 1167488 h 1246236"/>
                  <a:gd name="connsiteX8" fmla="*/ 5603 w 677758"/>
                  <a:gd name="connsiteY8" fmla="*/ 1122143 h 1246236"/>
                  <a:gd name="connsiteX9" fmla="*/ 479623 w 677758"/>
                  <a:gd name="connsiteY9" fmla="*/ 420754 h 1246236"/>
                  <a:gd name="connsiteX10" fmla="*/ 479623 w 677758"/>
                  <a:gd name="connsiteY10" fmla="*/ 32401 h 1246236"/>
                  <a:gd name="connsiteX11" fmla="*/ 512024 w 677758"/>
                  <a:gd name="connsiteY11" fmla="*/ 0 h 1246236"/>
                  <a:gd name="connsiteX12" fmla="*/ 641622 w 677758"/>
                  <a:gd name="connsiteY12" fmla="*/ 0 h 1246236"/>
                  <a:gd name="connsiteX13" fmla="*/ 664533 w 677758"/>
                  <a:gd name="connsiteY13" fmla="*/ 9490 h 12462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77758" h="1246236">
                    <a:moveTo>
                      <a:pt x="664533" y="9490"/>
                    </a:moveTo>
                    <a:cubicBezTo>
                      <a:pt x="670396" y="15353"/>
                      <a:pt x="674023" y="23454"/>
                      <a:pt x="674023" y="32401"/>
                    </a:cubicBezTo>
                    <a:lnTo>
                      <a:pt x="674023" y="456570"/>
                    </a:lnTo>
                    <a:lnTo>
                      <a:pt x="677161" y="461319"/>
                    </a:lnTo>
                    <a:cubicBezTo>
                      <a:pt x="678748" y="469525"/>
                      <a:pt x="677205" y="478336"/>
                      <a:pt x="672155" y="485808"/>
                    </a:cubicBezTo>
                    <a:lnTo>
                      <a:pt x="167949" y="1231862"/>
                    </a:lnTo>
                    <a:cubicBezTo>
                      <a:pt x="157850" y="1246806"/>
                      <a:pt x="137549" y="1250733"/>
                      <a:pt x="122605" y="1240633"/>
                    </a:cubicBezTo>
                    <a:lnTo>
                      <a:pt x="14375" y="1167488"/>
                    </a:lnTo>
                    <a:cubicBezTo>
                      <a:pt x="-570" y="1157388"/>
                      <a:pt x="-4497" y="1137087"/>
                      <a:pt x="5603" y="1122143"/>
                    </a:cubicBezTo>
                    <a:lnTo>
                      <a:pt x="479623" y="420754"/>
                    </a:lnTo>
                    <a:lnTo>
                      <a:pt x="479623" y="32401"/>
                    </a:lnTo>
                    <a:cubicBezTo>
                      <a:pt x="479623" y="14506"/>
                      <a:pt x="494129" y="0"/>
                      <a:pt x="512024" y="0"/>
                    </a:cubicBezTo>
                    <a:lnTo>
                      <a:pt x="641622" y="0"/>
                    </a:lnTo>
                    <a:cubicBezTo>
                      <a:pt x="650570" y="0"/>
                      <a:pt x="658670" y="3627"/>
                      <a:pt x="664533" y="9490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  <p:sp>
            <p:nvSpPr>
              <p:cNvPr id="1110" name="任意多边形: 形状 1109">
                <a:extLst>
                  <a:ext uri="{FF2B5EF4-FFF2-40B4-BE49-F238E27FC236}">
                    <a16:creationId xmlns:a16="http://schemas.microsoft.com/office/drawing/2014/main" id="{BE9647BA-DBC5-8873-87B9-C45A18F426C0}"/>
                  </a:ext>
                </a:extLst>
              </p:cNvPr>
              <p:cNvSpPr/>
              <p:nvPr/>
            </p:nvSpPr>
            <p:spPr>
              <a:xfrm rot="2076457" flipH="1">
                <a:off x="8963074" y="4069266"/>
                <a:ext cx="180000" cy="424502"/>
              </a:xfrm>
              <a:custGeom>
                <a:avLst/>
                <a:gdLst>
                  <a:gd name="connsiteX0" fmla="*/ 241077 w 251340"/>
                  <a:gd name="connsiteY0" fmla="*/ 274 h 541110"/>
                  <a:gd name="connsiteX1" fmla="*/ 251340 w 251340"/>
                  <a:gd name="connsiteY1" fmla="*/ 25052 h 541110"/>
                  <a:gd name="connsiteX2" fmla="*/ 251340 w 251340"/>
                  <a:gd name="connsiteY2" fmla="*/ 499219 h 541110"/>
                  <a:gd name="connsiteX3" fmla="*/ 209449 w 251340"/>
                  <a:gd name="connsiteY3" fmla="*/ 541110 h 541110"/>
                  <a:gd name="connsiteX4" fmla="*/ 41891 w 251340"/>
                  <a:gd name="connsiteY4" fmla="*/ 541110 h 541110"/>
                  <a:gd name="connsiteX5" fmla="*/ 0 w 251340"/>
                  <a:gd name="connsiteY5" fmla="*/ 499219 h 541110"/>
                  <a:gd name="connsiteX6" fmla="*/ 0 w 251340"/>
                  <a:gd name="connsiteY6" fmla="*/ 25052 h 541110"/>
                  <a:gd name="connsiteX7" fmla="*/ 10377 w 251340"/>
                  <a:gd name="connsiteY7" fmla="*/ 0 h 541110"/>
                  <a:gd name="connsiteX8" fmla="*/ 28020 w 251340"/>
                  <a:gd name="connsiteY8" fmla="*/ 29025 h 541110"/>
                  <a:gd name="connsiteX9" fmla="*/ 214870 w 251340"/>
                  <a:gd name="connsiteY9" fmla="*/ 36506 h 5411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1340" h="541110">
                    <a:moveTo>
                      <a:pt x="241077" y="274"/>
                    </a:moveTo>
                    <a:lnTo>
                      <a:pt x="251340" y="25052"/>
                    </a:lnTo>
                    <a:lnTo>
                      <a:pt x="251340" y="499219"/>
                    </a:lnTo>
                    <a:cubicBezTo>
                      <a:pt x="251340" y="522355"/>
                      <a:pt x="232585" y="541110"/>
                      <a:pt x="209449" y="541110"/>
                    </a:cubicBezTo>
                    <a:lnTo>
                      <a:pt x="41891" y="541110"/>
                    </a:lnTo>
                    <a:cubicBezTo>
                      <a:pt x="18755" y="541110"/>
                      <a:pt x="0" y="522355"/>
                      <a:pt x="0" y="499219"/>
                    </a:cubicBezTo>
                    <a:lnTo>
                      <a:pt x="0" y="25052"/>
                    </a:lnTo>
                    <a:lnTo>
                      <a:pt x="10377" y="0"/>
                    </a:lnTo>
                    <a:lnTo>
                      <a:pt x="28020" y="29025"/>
                    </a:lnTo>
                    <a:cubicBezTo>
                      <a:pt x="77552" y="82688"/>
                      <a:pt x="161208" y="86037"/>
                      <a:pt x="214870" y="36506"/>
                    </a:cubicBezTo>
                    <a:close/>
                  </a:path>
                </a:pathLst>
              </a:custGeom>
              <a:grpFill/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p3d>
                <a:bevelT w="190500" h="38100"/>
              </a:sp3d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zh-CN" altLang="en-US"/>
              </a:p>
            </p:txBody>
          </p:sp>
        </p:grpSp>
      </p:grpSp>
      <p:pic>
        <p:nvPicPr>
          <p:cNvPr id="3" name="图形 2">
            <a:extLst>
              <a:ext uri="{FF2B5EF4-FFF2-40B4-BE49-F238E27FC236}">
                <a16:creationId xmlns:a16="http://schemas.microsoft.com/office/drawing/2014/main" id="{335A8F59-5C9A-FDCB-0CC8-C36D7D3934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965391" y="1367157"/>
            <a:ext cx="5300370" cy="3085087"/>
          </a:xfrm>
          <a:prstGeom prst="rect">
            <a:avLst/>
          </a:prstGeom>
          <a:ln>
            <a:noFill/>
          </a:ln>
          <a:effectLst>
            <a:outerShdw blurRad="225425" dist="50800" dir="5220000" algn="ctr">
              <a:srgbClr val="000000">
                <a:alpha val="33000"/>
              </a:srgbClr>
            </a:outerShdw>
          </a:effectLst>
          <a:scene3d>
            <a:camera prst="perspectiveFront" fov="3300000">
              <a:rot lat="486000" lon="19530000" rev="174000"/>
            </a:camera>
            <a:lightRig rig="harsh" dir="t">
              <a:rot lat="0" lon="0" rev="3000000"/>
            </a:lightRig>
          </a:scene3d>
          <a:sp3d extrusionH="254000" contourW="19050">
            <a:bevelT w="82550" h="44450" prst="angle"/>
            <a:bevelB w="82550" h="44450" prst="angle"/>
            <a:contourClr>
              <a:srgbClr val="FFFFFF"/>
            </a:contourClr>
          </a:sp3d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C0DEA6C-E352-082C-1220-58B72894B63B}"/>
              </a:ext>
            </a:extLst>
          </p:cNvPr>
          <p:cNvSpPr txBox="1"/>
          <p:nvPr/>
        </p:nvSpPr>
        <p:spPr>
          <a:xfrm>
            <a:off x="1322447" y="4884665"/>
            <a:ext cx="10081006" cy="1294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-CD47mAb has gained considerable attention in recent years because of its potential as a therapy for hematologic malignancies and solid tumors. </a:t>
            </a:r>
          </a:p>
          <a:p>
            <a:pPr lvl="0" algn="just">
              <a:lnSpc>
                <a:spcPct val="150000"/>
              </a:lnSpc>
            </a:pPr>
            <a:r>
              <a:rPr lang="zh-CN" altLang="en-US" b="0" i="0" dirty="0">
                <a:solidFill>
                  <a:srgbClr val="2A2B2E"/>
                </a:solidFill>
                <a:effectLst/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近年来，</a:t>
            </a:r>
            <a:r>
              <a:rPr lang="en-US" altLang="zh-CN" sz="1800" kern="100" dirty="0">
                <a:effectLst/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 Anti-CD47</a:t>
            </a:r>
            <a:r>
              <a:rPr lang="zh-CN" altLang="en-US" sz="1800" kern="100" dirty="0">
                <a:effectLst/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单抗</a:t>
            </a:r>
            <a:r>
              <a:rPr lang="zh-CN" altLang="en-US" b="0" i="0" dirty="0">
                <a:solidFill>
                  <a:srgbClr val="2A2B2E"/>
                </a:solidFill>
                <a:effectLst/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作为血液恶性肿瘤和实体肿瘤的潜在治疗药物，引起了全球广泛关注。</a:t>
            </a:r>
            <a:endParaRPr lang="zh-CN" altLang="zh-CN" sz="1800" kern="100" dirty="0">
              <a:effectLst/>
              <a:latin typeface="微软雅黑" panose="020B0503020204020204" pitchFamily="34" charset="-122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" name="箭头: 右 9">
            <a:extLst>
              <a:ext uri="{FF2B5EF4-FFF2-40B4-BE49-F238E27FC236}">
                <a16:creationId xmlns:a16="http://schemas.microsoft.com/office/drawing/2014/main" id="{841370D6-EA04-17DE-4C70-AEFBECE1F109}"/>
              </a:ext>
            </a:extLst>
          </p:cNvPr>
          <p:cNvSpPr/>
          <p:nvPr/>
        </p:nvSpPr>
        <p:spPr>
          <a:xfrm rot="405061">
            <a:off x="6965326" y="2654169"/>
            <a:ext cx="700490" cy="521789"/>
          </a:xfrm>
          <a:prstGeom prst="rightArrow">
            <a:avLst/>
          </a:prstGeom>
          <a:solidFill>
            <a:schemeClr val="accent1">
              <a:lumMod val="75000"/>
            </a:schemeClr>
          </a:solidFill>
          <a:ln w="34925">
            <a:solidFill>
              <a:srgbClr val="FFFFFF"/>
            </a:solidFill>
          </a:ln>
          <a:effectLst>
            <a:outerShdw blurRad="317500" dir="2700000" algn="ctr">
              <a:srgbClr val="000000">
                <a:alpha val="43000"/>
              </a:srgbClr>
            </a:outerShdw>
          </a:effectLst>
          <a:scene3d>
            <a:camera prst="perspectiveFront" fov="2700000">
              <a:rot lat="19086000" lon="19067999" rev="3108000"/>
            </a:camera>
            <a:lightRig rig="threePt" dir="t">
              <a:rot lat="0" lon="0" rev="0"/>
            </a:lightRig>
          </a:scene3d>
          <a:sp3d extrusionH="38100" prstMaterial="clear">
            <a:bevelT w="260350" h="50800" prst="softRound"/>
            <a:bevelB prst="softRound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56212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4B438FE-C0BD-1F48-4810-D28740E8C30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4" r="5838"/>
          <a:stretch/>
        </p:blipFill>
        <p:spPr>
          <a:xfrm>
            <a:off x="3180204" y="618371"/>
            <a:ext cx="5617923" cy="377323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FDC9EDE-0821-C445-F6D3-C609ED2BF255}"/>
              </a:ext>
            </a:extLst>
          </p:cNvPr>
          <p:cNvSpPr txBox="1"/>
          <p:nvPr/>
        </p:nvSpPr>
        <p:spPr>
          <a:xfrm>
            <a:off x="728186" y="4526912"/>
            <a:ext cx="10632112" cy="17054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owever, there are many CD47 on red blood cells(RBCs) membranes. In the pre-tests of transfusion, anti-CD47mAb binds to CD47 of RBCs, which may lead to false-positive  reaction.</a:t>
            </a:r>
          </a:p>
          <a:p>
            <a:pPr algn="just">
              <a:lnSpc>
                <a:spcPct val="150000"/>
              </a:lnSpc>
            </a:pP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然而红细胞膜上有许多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。在输血前检测中，抗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-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单抗与红细胞的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结合，可能导致假阳性反应。</a:t>
            </a:r>
            <a:endParaRPr lang="zh-CN" altLang="zh-CN" kern="100" dirty="0">
              <a:latin typeface="微软雅黑" panose="020B0503020204020204" pitchFamily="34" charset="-122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5415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17E8285-67A4-E1C8-B056-4EF3EEC78254}"/>
              </a:ext>
            </a:extLst>
          </p:cNvPr>
          <p:cNvSpPr txBox="1"/>
          <p:nvPr/>
        </p:nvSpPr>
        <p:spPr>
          <a:xfrm>
            <a:off x="1219708" y="4748486"/>
            <a:ext cx="10117908" cy="17054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o deplete the interference of anti-CD47mAb in pre-transfusion testing, CD47</a:t>
            </a:r>
            <a:r>
              <a:rPr lang="en-US" altLang="zh-CN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gh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93T cells were produced using a lentiviral delivery system. </a:t>
            </a:r>
          </a:p>
          <a:p>
            <a:pPr lvl="0" algn="just">
              <a:lnSpc>
                <a:spcPct val="150000"/>
              </a:lnSpc>
            </a:pP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为消除输血前检测中抗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-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单抗的干扰，使用慢病毒系统表达制备了高表达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的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HEK-293T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细胞。</a:t>
            </a:r>
            <a:endParaRPr lang="zh-CN" altLang="zh-CN" kern="100" dirty="0">
              <a:latin typeface="微软雅黑" panose="020B0503020204020204" pitchFamily="34" charset="-122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479C3AF-7262-BA9F-2848-A0BFE2DF3F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2700" y="2013379"/>
            <a:ext cx="6732634" cy="210489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F2F8A37-46C7-8104-2E58-F3156F447272}"/>
              </a:ext>
            </a:extLst>
          </p:cNvPr>
          <p:cNvSpPr txBox="1"/>
          <p:nvPr/>
        </p:nvSpPr>
        <p:spPr>
          <a:xfrm>
            <a:off x="4036028" y="1957616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D47</a:t>
            </a:r>
            <a:endParaRPr lang="zh-CN" altLang="en-US" sz="12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534DD61-D772-F8B3-6C0D-FDD79475B67D}"/>
              </a:ext>
            </a:extLst>
          </p:cNvPr>
          <p:cNvSpPr txBox="1"/>
          <p:nvPr/>
        </p:nvSpPr>
        <p:spPr>
          <a:xfrm>
            <a:off x="7505702" y="1957616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Puro(R)</a:t>
            </a:r>
            <a:endParaRPr lang="zh-CN" altLang="en-US" sz="12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048246B-0B8F-8B55-A740-78D6736609D4}"/>
              </a:ext>
            </a:extLst>
          </p:cNvPr>
          <p:cNvSpPr txBox="1"/>
          <p:nvPr/>
        </p:nvSpPr>
        <p:spPr>
          <a:xfrm>
            <a:off x="5858478" y="1957615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EGFP</a:t>
            </a:r>
            <a:endParaRPr lang="zh-CN" altLang="en-US" sz="12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ACC612F-0A61-CBCF-192B-5426F2FFF82B}"/>
              </a:ext>
            </a:extLst>
          </p:cNvPr>
          <p:cNvSpPr txBox="1"/>
          <p:nvPr/>
        </p:nvSpPr>
        <p:spPr>
          <a:xfrm>
            <a:off x="4218690" y="3050204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nfect</a:t>
            </a:r>
            <a:endParaRPr lang="zh-CN" altLang="en-US" sz="12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E547F21-6EA9-A352-AAA7-66B51B81FE65}"/>
              </a:ext>
            </a:extLst>
          </p:cNvPr>
          <p:cNvSpPr txBox="1"/>
          <p:nvPr/>
        </p:nvSpPr>
        <p:spPr>
          <a:xfrm>
            <a:off x="5858478" y="3065828"/>
            <a:ext cx="8563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antibiotic</a:t>
            </a:r>
          </a:p>
          <a:p>
            <a:r>
              <a:rPr lang="en-US" altLang="zh-CN" sz="1200" b="1" dirty="0"/>
              <a:t>screening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060C28C-5A1D-6F49-1309-148642AB96D1}"/>
              </a:ext>
            </a:extLst>
          </p:cNvPr>
          <p:cNvSpPr txBox="1"/>
          <p:nvPr/>
        </p:nvSpPr>
        <p:spPr>
          <a:xfrm>
            <a:off x="7859510" y="3072178"/>
            <a:ext cx="6783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   cell</a:t>
            </a:r>
          </a:p>
          <a:p>
            <a:r>
              <a:rPr lang="en-US" altLang="zh-CN" sz="1200" b="1" dirty="0"/>
              <a:t>sorting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5B281AC-8157-89F6-A6AA-C3E4DFE0F5E0}"/>
              </a:ext>
            </a:extLst>
          </p:cNvPr>
          <p:cNvSpPr txBox="1"/>
          <p:nvPr/>
        </p:nvSpPr>
        <p:spPr>
          <a:xfrm>
            <a:off x="2686200" y="4091986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virus</a:t>
            </a:r>
            <a:endParaRPr lang="zh-CN" altLang="en-US" sz="12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4555C2A-C6F5-04C9-63E0-F22826EFA627}"/>
              </a:ext>
            </a:extLst>
          </p:cNvPr>
          <p:cNvSpPr txBox="1"/>
          <p:nvPr/>
        </p:nvSpPr>
        <p:spPr>
          <a:xfrm>
            <a:off x="4982059" y="4174041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293T cell</a:t>
            </a:r>
            <a:endParaRPr lang="zh-CN" altLang="en-US" sz="12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3DD653C-40E7-7C34-9B88-E69E37E8CB23}"/>
              </a:ext>
            </a:extLst>
          </p:cNvPr>
          <p:cNvSpPr txBox="1"/>
          <p:nvPr/>
        </p:nvSpPr>
        <p:spPr>
          <a:xfrm>
            <a:off x="6957691" y="3684494"/>
            <a:ext cx="9717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transfected</a:t>
            </a:r>
          </a:p>
          <a:p>
            <a:r>
              <a:rPr lang="en-US" altLang="zh-CN" sz="1200" b="1" dirty="0"/>
              <a:t> 293T cell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653248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AA845E13-F7EF-1BEA-B8EC-C260CE12C8D5}"/>
              </a:ext>
            </a:extLst>
          </p:cNvPr>
          <p:cNvSpPr txBox="1"/>
          <p:nvPr/>
        </p:nvSpPr>
        <p:spPr>
          <a:xfrm>
            <a:off x="868392" y="4633474"/>
            <a:ext cx="10304875" cy="2120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dified HEK-293T cells were mixed with plasma and incubated for 20 min at 37 ℃. Then the HEK-293T cells were removed by centrifugation at 1000 ×g for 5 min, and the supernatant was collected for pre-transfusion testing.</a:t>
            </a:r>
          </a:p>
          <a:p>
            <a:pPr lvl="0" algn="just">
              <a:lnSpc>
                <a:spcPct val="150000"/>
              </a:lnSpc>
            </a:pP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将过表达的细胞与血浆混合，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37℃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孵育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20 min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。在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1000 ×g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下离心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5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分钟，取出细胞，收集上清进行输血前检测。</a:t>
            </a:r>
            <a:endParaRPr lang="zh-CN" altLang="zh-CN" kern="100" dirty="0">
              <a:latin typeface="微软雅黑" panose="020B0503020204020204" pitchFamily="34" charset="-122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9428102-EA85-E612-F8FC-6FA54B0F90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7810" y="2469467"/>
            <a:ext cx="4549390" cy="149003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4B8BC0C-4DC5-7D3E-2B29-FF4CC0C1EF7D}"/>
              </a:ext>
            </a:extLst>
          </p:cNvPr>
          <p:cNvSpPr txBox="1"/>
          <p:nvPr/>
        </p:nvSpPr>
        <p:spPr>
          <a:xfrm>
            <a:off x="4721312" y="2992025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37</a:t>
            </a:r>
            <a:r>
              <a:rPr lang="zh-CN" altLang="en-US" sz="1200" b="1" dirty="0"/>
              <a:t>℃，</a:t>
            </a:r>
            <a:r>
              <a:rPr lang="en-US" altLang="zh-CN" sz="1200" b="1" dirty="0"/>
              <a:t>20min</a:t>
            </a:r>
            <a:endParaRPr lang="zh-CN" altLang="en-US" sz="12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1DCEF0F-5842-298E-D027-1569B08EAA15}"/>
              </a:ext>
            </a:extLst>
          </p:cNvPr>
          <p:cNvSpPr txBox="1"/>
          <p:nvPr/>
        </p:nvSpPr>
        <p:spPr>
          <a:xfrm>
            <a:off x="6711950" y="2992025"/>
            <a:ext cx="11544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1000×g,</a:t>
            </a:r>
            <a:r>
              <a:rPr lang="zh-CN" altLang="en-US" sz="1200" b="1" dirty="0"/>
              <a:t> </a:t>
            </a:r>
            <a:r>
              <a:rPr lang="en-US" altLang="zh-CN" sz="1200" b="1" dirty="0"/>
              <a:t>5min</a:t>
            </a:r>
            <a:endParaRPr lang="zh-CN" altLang="en-US" sz="12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12F5F42-25A8-E6B9-E8E6-7E874284E5E4}"/>
              </a:ext>
            </a:extLst>
          </p:cNvPr>
          <p:cNvSpPr txBox="1"/>
          <p:nvPr/>
        </p:nvSpPr>
        <p:spPr>
          <a:xfrm>
            <a:off x="3553210" y="2154676"/>
            <a:ext cx="1117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C00000"/>
                </a:solidFill>
              </a:rPr>
              <a:t>Anti-RBC </a:t>
            </a:r>
            <a:r>
              <a:rPr lang="en-US" altLang="zh-CN" sz="1200" b="1" dirty="0" err="1">
                <a:solidFill>
                  <a:srgbClr val="C00000"/>
                </a:solidFill>
              </a:rPr>
              <a:t>lgG</a:t>
            </a:r>
            <a:endParaRPr lang="en-US" altLang="zh-CN" sz="1200" b="1" dirty="0">
              <a:solidFill>
                <a:srgbClr val="C00000"/>
              </a:solidFill>
            </a:endParaRPr>
          </a:p>
          <a:p>
            <a:r>
              <a:rPr lang="en-US" altLang="zh-CN" sz="1200" b="1" dirty="0"/>
              <a:t>  Other </a:t>
            </a:r>
            <a:r>
              <a:rPr lang="en-US" altLang="zh-CN" sz="1200" b="1" dirty="0" err="1"/>
              <a:t>lgG</a:t>
            </a:r>
            <a:endParaRPr lang="zh-CN" altLang="en-US" sz="12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94393E8-254D-B318-CEEB-6FB64D8BE693}"/>
              </a:ext>
            </a:extLst>
          </p:cNvPr>
          <p:cNvSpPr txBox="1"/>
          <p:nvPr/>
        </p:nvSpPr>
        <p:spPr>
          <a:xfrm>
            <a:off x="3697971" y="3941204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chemeClr val="accent1">
                    <a:lumMod val="75000"/>
                  </a:schemeClr>
                </a:solidFill>
              </a:rPr>
              <a:t>Anti CD47</a:t>
            </a:r>
            <a:endParaRPr lang="zh-CN" altLang="en-US" sz="12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AB8621B-7F3D-D581-33F9-5254D23DFD50}"/>
              </a:ext>
            </a:extLst>
          </p:cNvPr>
          <p:cNvSpPr txBox="1"/>
          <p:nvPr/>
        </p:nvSpPr>
        <p:spPr>
          <a:xfrm>
            <a:off x="5619884" y="3962650"/>
            <a:ext cx="1426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chemeClr val="accent4">
                    <a:lumMod val="75000"/>
                  </a:schemeClr>
                </a:solidFill>
              </a:rPr>
              <a:t>CD47</a:t>
            </a:r>
            <a:r>
              <a:rPr lang="en-US" altLang="zh-CN" sz="1200" b="1" baseline="30000" dirty="0">
                <a:solidFill>
                  <a:schemeClr val="accent4">
                    <a:lumMod val="75000"/>
                  </a:schemeClr>
                </a:solidFill>
              </a:rPr>
              <a:t>high</a:t>
            </a:r>
            <a:r>
              <a:rPr lang="en-US" altLang="zh-CN" sz="1200" b="1" dirty="0">
                <a:solidFill>
                  <a:schemeClr val="accent4">
                    <a:lumMod val="75000"/>
                  </a:schemeClr>
                </a:solidFill>
              </a:rPr>
              <a:t> 293T cell</a:t>
            </a:r>
            <a:endParaRPr lang="zh-CN" altLang="en-US" sz="1200" b="1" dirty="0">
              <a:solidFill>
                <a:schemeClr val="accent4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901518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4B94A95F-9976-65C4-925B-6A8F720F11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122"/>
          <a:stretch/>
        </p:blipFill>
        <p:spPr>
          <a:xfrm>
            <a:off x="1345946" y="1206058"/>
            <a:ext cx="9199257" cy="247777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EE8338A-4A46-E7C1-157B-2F35000F3DFA}"/>
              </a:ext>
            </a:extLst>
          </p:cNvPr>
          <p:cNvSpPr txBox="1"/>
          <p:nvPr/>
        </p:nvSpPr>
        <p:spPr>
          <a:xfrm>
            <a:off x="556536" y="4054414"/>
            <a:ext cx="11152385" cy="8742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fter adsorption, interference from anti-CD47mAb in pre-transfusion testing were eliminated. </a:t>
            </a:r>
            <a:endParaRPr lang="zh-CN" altLang="en-US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吸附后消除了</a:t>
            </a:r>
            <a:r>
              <a:rPr lang="en-US" altLang="zh-CN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CD47</a:t>
            </a:r>
            <a:r>
              <a:rPr lang="zh-CN" altLang="en-US" kern="100" dirty="0">
                <a:latin typeface="微软雅黑" panose="020B0503020204020204" pitchFamily="34" charset="-122"/>
                <a:ea typeface="微软雅黑" panose="020B0503020204020204" pitchFamily="34" charset="-122"/>
                <a:cs typeface="Times New Roman" panose="02020603050405020304" pitchFamily="18" charset="0"/>
              </a:rPr>
              <a:t>单抗对输血前检测的干扰。</a:t>
            </a:r>
            <a:endParaRPr lang="zh-CN" altLang="zh-CN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13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</TotalTime>
  <Words>300</Words>
  <Application>Microsoft Office PowerPoint</Application>
  <PresentationFormat>宽屏</PresentationFormat>
  <Paragraphs>30</Paragraphs>
  <Slides>5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微软雅黑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Yutong</dc:creator>
  <cp:lastModifiedBy>hxbyqh@outlook.com</cp:lastModifiedBy>
  <cp:revision>15</cp:revision>
  <dcterms:created xsi:type="dcterms:W3CDTF">2023-07-04T09:46:24Z</dcterms:created>
  <dcterms:modified xsi:type="dcterms:W3CDTF">2023-07-07T00:13:54Z</dcterms:modified>
</cp:coreProperties>
</file>